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0" r:id="rId2"/>
    <p:sldId id="272" r:id="rId3"/>
    <p:sldId id="273" r:id="rId4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0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74" autoAdjust="0"/>
    <p:restoredTop sz="94660"/>
  </p:normalViewPr>
  <p:slideViewPr>
    <p:cSldViewPr snapToGrid="0">
      <p:cViewPr varScale="1">
        <p:scale>
          <a:sx n="98" d="100"/>
          <a:sy n="98" d="100"/>
        </p:scale>
        <p:origin x="1002" y="72"/>
      </p:cViewPr>
      <p:guideLst>
        <p:guide orient="horz" pos="100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 smtClean="0"/>
              <a:t>Kliknutím lz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6441-A966-48DB-85C4-BA6BC9D194F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809693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26DC8-E51D-481D-AAD8-A43A9DFD3B2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148115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BD760-98FC-4C08-A0F8-5A963CD3BC8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040279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79005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949C4-1DE5-4F70-8142-6CF1BB24FEA7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720956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8FA0B-0612-4E20-BCBE-87F7BED20B0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954897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D3FC5-249B-4B4C-A869-F27D2287A69E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082196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286D-970A-40DF-86E4-A03FBAF9B186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052769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B30D-BE39-4293-9BDC-450C31B1B31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13342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4F7FA-888C-4CDC-ACC9-A1F66DFE1ECB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88965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cs-CZ" smtClean="0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14D75-D436-47E2-BF8B-27FD76561BE0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588006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56513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3.jpe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olný tvar 1"/>
          <p:cNvSpPr/>
          <p:nvPr/>
        </p:nvSpPr>
        <p:spPr>
          <a:xfrm>
            <a:off x="162000" y="1412385"/>
            <a:ext cx="8820000" cy="4033231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low-pass, NAD and angular filters on a 5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nm</a:t>
            </a:r>
          </a:p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</a:t>
            </a: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thick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x-z </a:t>
            </a: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ross section of a </a:t>
            </a:r>
            <a:r>
              <a:rPr lang="en-US" sz="2400" b="1" i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T. </a:t>
            </a:r>
            <a:r>
              <a:rPr lang="en-US" sz="2400" b="1" i="1" dirty="0" err="1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brucei</a:t>
            </a: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weighted </a:t>
            </a:r>
          </a:p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back-projection reconstruction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42895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779518" y="5963056"/>
            <a:ext cx="7584963" cy="787940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>
              <a:lnSpc>
                <a:spcPct val="150000"/>
              </a:lnSpc>
            </a:pPr>
            <a:r>
              <a:rPr lang="en-US" b="1" u="sng" dirty="0" smtClean="0"/>
              <a:t>1. Low-pass filter: </a:t>
            </a:r>
            <a:r>
              <a:rPr lang="en-US" dirty="0" smtClean="0"/>
              <a:t>3 nm cut-off, </a:t>
            </a:r>
            <a:r>
              <a:rPr lang="en-US" b="1" u="sng" dirty="0" smtClean="0"/>
              <a:t>2. NAD filter:</a:t>
            </a:r>
            <a:r>
              <a:rPr lang="en-US" dirty="0" smtClean="0"/>
              <a:t> k=0.01, 20 iterations</a:t>
            </a:r>
            <a:endParaRPr lang="cs-CZ" dirty="0" smtClean="0"/>
          </a:p>
        </p:txBody>
      </p:sp>
      <p:pic>
        <p:nvPicPr>
          <p:cNvPr id="9" name="Obrázek 8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172" y="1905277"/>
            <a:ext cx="8677656" cy="30474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2457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58368" y="5963056"/>
            <a:ext cx="9014791" cy="787940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b="1" u="sng" dirty="0" smtClean="0"/>
              <a:t>Low-pass filter: </a:t>
            </a:r>
            <a:r>
              <a:rPr lang="en-US" dirty="0" smtClean="0"/>
              <a:t>3 nm cut-off, </a:t>
            </a:r>
            <a:r>
              <a:rPr lang="en-US" b="1" u="sng" dirty="0" smtClean="0"/>
              <a:t>2. angular filter:</a:t>
            </a:r>
            <a:r>
              <a:rPr lang="en-US" dirty="0" smtClean="0"/>
              <a:t> MW length: 65, MW order: 4, MW weight: 0.2, CS length: 30, CS order: 4, CS half-width:10, </a:t>
            </a:r>
            <a:r>
              <a:rPr lang="en-US" b="1" u="sng" dirty="0" smtClean="0"/>
              <a:t>3. NAD filter:</a:t>
            </a:r>
            <a:r>
              <a:rPr lang="en-US" dirty="0" smtClean="0"/>
              <a:t> k=0.01, 20 iterations</a:t>
            </a:r>
            <a:endParaRPr lang="cs-CZ" dirty="0" smtClean="0"/>
          </a:p>
        </p:txBody>
      </p:sp>
      <p:pic>
        <p:nvPicPr>
          <p:cNvPr id="7" name="Obrázek 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172" y="1905277"/>
            <a:ext cx="8677656" cy="30474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201061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</TotalTime>
  <Words>92</Words>
  <Application>Microsoft Office PowerPoint</Application>
  <PresentationFormat>Předvádění na obrazovce (4:3)</PresentationFormat>
  <Paragraphs>7</Paragraphs>
  <Slides>3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4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ahoma</vt:lpstr>
      <vt:lpstr>Default</vt:lpstr>
      <vt:lpstr>Prezentace aplikace PowerPoint</vt:lpstr>
      <vt:lpstr>Prezentace aplikace PowerPoint</vt:lpstr>
      <vt:lpstr>Prezentace aplikace PowerPoint</vt:lpstr>
    </vt:vector>
  </TitlesOfParts>
  <Company>UBBP 1. LF U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bomir Kovacik</dc:creator>
  <cp:lastModifiedBy>Lubomir Kovacik</cp:lastModifiedBy>
  <cp:revision>36</cp:revision>
  <dcterms:created xsi:type="dcterms:W3CDTF">2014-01-07T09:01:08Z</dcterms:created>
  <dcterms:modified xsi:type="dcterms:W3CDTF">2014-01-07T11:50:21Z</dcterms:modified>
</cp:coreProperties>
</file>